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D0DFA5-D71B-434A-91BB-79FE473431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947E45-3D67-47AE-83F3-9472758A20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481C3-4CEA-47FD-95FC-B88A3D9E91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56AAC-28D6-4DF6-9A32-090B088983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E769E-DC54-498B-A10F-A01BBA320C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B7688-7289-49F2-A6A8-73405D3BC3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C26FA-A618-4F39-8313-4FE98CBBC9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38F0F8-AB09-4A53-84BA-288FC71077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29EEB-71A9-4850-B858-7A85770D9C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7594D-0D79-40FC-B63C-CD5301ECDE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1BE87-B509-48B8-AB4B-90B02CC60B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C7CC9-C219-4DAA-BE1B-0FC128A0D5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4AABE7-554C-4BB2-95C3-D63811956DD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480024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Figure S10: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Correlation between copy number of a genomic region derived from oligonucleotide SNP chip and fluorescent intensity derived from Luminex based assay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743200" y="685800"/>
            <a:ext cx="3733920" cy="4038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23T22:36:52Z</dcterms:created>
  <dc:creator>mkibriya</dc:creator>
  <dc:description/>
  <dc:language>en-US</dc:language>
  <cp:lastModifiedBy>mkibriya</cp:lastModifiedBy>
  <dcterms:modified xsi:type="dcterms:W3CDTF">2017-05-30T17:18:00Z</dcterms:modified>
  <cp:revision>38</cp:revision>
  <dc:subject/>
  <dc:title>Slide 1</dc:title>
</cp:coreProperties>
</file>